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309" r:id="rId3"/>
    <p:sldId id="308" r:id="rId4"/>
    <p:sldId id="304" r:id="rId5"/>
    <p:sldId id="307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21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h" initials="k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77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-60" y="1794"/>
      </p:cViewPr>
      <p:guideLst>
        <p:guide orient="horz" pos="3119"/>
        <p:guide pos="221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presProps" Target="presProps.xml"/><Relationship Id="rId8" Type="http://schemas.openxmlformats.org/officeDocument/2006/relationships/handoutMaster" Target="handoutMasters/handoutMaster1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2" Type="http://schemas.openxmlformats.org/officeDocument/2006/relationships/commentAuthors" Target="commentAuthors.xml"/><Relationship Id="rId11" Type="http://schemas.openxmlformats.org/officeDocument/2006/relationships/tableStyles" Target="tableStyles.xml"/><Relationship Id="rId10" Type="http://schemas.openxmlformats.org/officeDocument/2006/relationships/viewProps" Target="viewProps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20815-1008-4CE7-954C-C7A6E03427E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151D6E-CE0D-4D6C-8DC7-A1F96315E03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" name="文本框 5"/>
          <p:cNvSpPr txBox="1"/>
          <p:nvPr/>
        </p:nvSpPr>
        <p:spPr>
          <a:xfrm>
            <a:off x="348615" y="9184005"/>
            <a:ext cx="6095365" cy="41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lnSpc>
                <a:spcPct val="1300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omic locations and sequence information of potential off-target sites</a:t>
            </a:r>
            <a:r>
              <a:rPr lang="en-US" altLang="zh-CN" sz="8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 to 6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ith the potential target sites highlighted in yellow.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60350" y="218440"/>
            <a:ext cx="6148070" cy="8703945"/>
          </a:xfrm>
          <a:prstGeom prst="rect">
            <a:avLst/>
          </a:prstGeom>
        </p:spPr>
        <p:txBody>
          <a:bodyPr>
            <a:no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OFF-target sites 1: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&gt;Os01g0621200 class=Sequence_position=chr01:24753864..24758578 (-strand) ATGGCGCACGCGGCGTTCGACGCCGAGGCCGGCGCGGCCGCCAAGCCGCCCGCCGCCGACGCCGGCGCCGCCTTCGTGCTCGAGTCCAAAGGTAGGTCACACCCCTCCACCCCCCGCCCGCCTTCCGCGCGCAATGCGAGGGCTGATTCTGCTGTGATCTGTGGTTGGGTCCCGTCGCGGGGCGACCTTGCAGGGACGTGGTGGCACGCCGGGTTCCACCTGACGACGGCGATCGTGGGGCCGACGGTGCTGACGCTGCCGTACGCGCTGCGCGGGATGGGGTGGGCGCTGGGACTCACCGTGCTCACCGCCGTCGGCGCCGTCACCTTCTACGAGTACTCCCTCATGTCCCGCGTCCTCGAGCACTGCGAGGCCCGCGGCCGCCGCCACATCCGCTTCCGCGAGCTCGCCGCCGACGTCCTCGGTATTACTATTAACTCCCCTGATCCATTCCTTTCCACTGCACCCCATCACCACACGCACATGACATTCCCGTGTATTGCCCCATGTGCGTTCGGTGCAATGCCCACAAGCGAAGCAGACAGCTTTAGCTACCCGCATCAATGCTCGTTTGGACGCAGCGCGGCGCCGCGCGCGCGCCTTTGTGCACGGGCGGCGGTGGAGCAGCCAGCGACACAGTCACACTAGCTGCCGTGCTGTTGCCGACTCGCCGCCATGCTCCCATTAATTAGGATGGCGCGCGTTGGTGAGCTCGCCAACGCAAAGACACAAAATTAATTATCGACATGATAGTATCGCTTTTTCTTTTGTTCGTCTGCTCCTGCACGCAGGGTCCGGGTGGATGTTTTACTTCGTGGTCATCGTGCAGACGGCCATCAACACCGGCGTTAGCATCGGCACCATCCTGCTCGCCGCCGATTGCCTCGAGGTGCAAATCGTTGCTTCCCATAACCCCCTTGAACTCTCTGTCTGATATGCATATAAGTTTAAGCTCATACTATTGCCAATTGCTGTTGTCTATGATTGGTTTATTGTTCGGAACAAAGTTTTCATGTCGTTTGTGTTTGGACAAGCTGTAGTATATCCAACAAATTGGGAATGCCTGGACATAGTTGCCGTACAAAATCAAGAAGCTATCATGCTCTTAATGTGAATGTAGAATATGAATAAGATATCGTATTGCATAGATCAATAAATATTTGGCCATCCATGTTTGTTGTGATCTAAATGGTTGGCTCTGATGAATTTGACTCGAGCTGCTTCAGGATAGGAGGGTTGCTTTCTGTTATCCAGTATCCACTGACGCAACGACAGAAATTCAAACTAGTAAGAAAGCTGGTCCCAGACGATATGCTGGCATGCTAATTTTGCTAATGCGTGTGGGAGGATTCATACTATGGTTATTAATATTTTATTGGCTTTGCTTGTGGGTTTGTAATATGCAAGCAAGTCATAATCATGCAACCAATAAGTaatactacctccgtccaaaaataagtttagttttgcacggttcatatttaacgtttgaccgtttgtcttatttgaaaaaaaaattatgattagtatttttattgttattagatgatagaacctgaatagtactttacgtgtgactttttttaataaaaaattcataaatttttcaaataagacggacggtcaaacgttggatacggatacctatggctgcacttactttgggatggaggtagtaAGTAATAACGAAGTCCTGCAATGGATATTGATGGCTATGCATCGCTCTAGTAGTTCTAATTTGAAACAGGTATAGGTTGTTTCCTGTTCATTTGATTGCAAATATCCACAATAAAAGCTAAACTTATTTTTGGAACAAAACCTGATCACTGATTGTAAAAGCAAAGGAAATAAACCCTATGCTGCTGTGCAATTTTCATGTGCTTGTACTTCTGACCTTGGAAGGATTGAACATATGGCTATTGAAGGCTAACTCTAAAATTACATGATTTTATTCGTAGCATGTCTGCATAGCTGTCAACATACATCATTTTTTTTAGAGCTTAAAATTGTATGGAGGAAGAAGATATTCCAATCCTTGCATAGTCTCTTGCCTGCAACCTAAGTACTTCTATACTAAGTTCAGACAAGAAAACAATAAGGGGGCAGAATGATAGAACAGAACTGGCAATCCCATATTTTTTCTGTCAGAAAGGAGTCAGTACTGTAGTCGGCCTGCTAGTAATTACAATCTTCTAAAACTGTAAAGTCATTTACAGTTAGTGAAATTGCATAACAGATTTCGTCTATTGGCATGAAAAAACAACTAATTAATAACTTCTTTCTGTTCAGTGTTCACAGCTCAAATTATCAGTTGCAAAATTGGATAAACTGGTCTTTTGTTGTGCCCAAACAGATCATGTATACGAGCCTTTCTCCCAATGGTCCCCTGAAACTGTACCACTTCATCATCATAGTAGCTGTGGCGCTGGCCTTCCTCTCCCAGCTACCATCATTCCATTCCCTGCGGCACATTAACTTTGCCTCTCTGCTCTTGAGCTTGGGCTACACCATCCTTGTATCTGCTGCTTGCATTGGTGCAGGTATATCGCCTGAACTCTCGCGTCACATGTTCATTCCTCTCTGTGTTCCCAGAACTTTTCTGTTAAGATTTCAGAGAAACTTATGCTGCAGCAGATGGAGGAATTAGATTCCACAAAAGGTTGGGAATTAGATCGGGAATCAGATGCCCTATATCTATCAGTAGTATTCTTCATAAATATACAGTAAATTCTGCTCCATTGTTTATATAAACACAAGACAAAATACAAATGGAATGAACGTGATTACTGCGCTTTGCAGCCAATTCTTTTCAGTTGTTTTTTGATGCATGATAACGGAACAAACTCAACTAGGTATGATATGTCCACAAAACGCATTACTGTCGTTACTTATTAGACGTTTCAGATTCCAGTAAAAACCATTAGGAATTTTAACTTTTATGCCATTTTGTACCTGTAATTCTAATTTAGGCACAACACAAGCTATTTGATTGGTTTGGCCAGAACCAGACTTAACAAATTCATGATTACTAGTTCTTCAGCTACGCTATATCAGAAAACAAAATTGTACAACTGAGGGCTGCAGTTTGCACTGGTAGTTTAAGTGTCTAACTCTCATTGTCCTAGATGTTAACCATCATTCTTAACAGGTCTGTCAAAAGATGCTCCGGGGAAGGATTACACGCTTAGCTCGTCCAAATCAGAACAGACCTTCAATGCCTTCCTCTCTATTTCTATCCTGGCTTCTGTTTACGGCAACGGCATACTGCCTGAAATCCAGGTATTCATCATTGCGTCTTCTGACTTTTGATCAAGAAAAAAAAATCTGACTTAACGTACCTAGATCTAGATATGTTAAACACTTATCAGAAAAATCCCTTAGTGGAATCCAACAAGAGTTCTATGGCCATATTGGTAGATTCGCTAGTACTCTGAAATTACATGCTAGCCCTTTTTAGACTATCTGTTCCTCTGGAAATTATAAAGGAAAACACCGAAAACTGTAAGCCACCGCAATAgggactacctatacatttgtcgacaaatttttctccaaaaatttgatagatgtaattatagtacaatcgtagtgtaattacactgtaacttatatgtaattacactgtaacttgcatgtaactacagtgtaacttatatgtaagtttcacataattttgaatcgttggatctattacaagatttgttttggtgagaaagaaaacaaatcatagcacacacatatgtgaaagaatttgttcccacgacctccattttaccgaaataacatgtaacggagagatttttgaaagttacatacaagttacactatagttacagtgtaattacatgcaagttacagtgtaattacactacgattgtactgtaattacatctgtcaaattttgggggaaaaatttgtcgacaaatataTAGCAAAATCGCCGCAATATGGTCCAACTGACGCGACAGGCTGGGCTTATTGGGCTCCTAAAATTAAGCCCATATCAATTGTTAAAAAGCCCATATGAAGTGTTATGCGGGCCTATTTAGAAGATTTATGGTGGGCCGTTTTCAAATCGGCGTTTGCAGGCCACGTTGGCGCCACCGGCGGCCGGGAAGATGATGAAGGCGCTTGTGCTGTGCTACTCCGTCATAGCCTTCGCCTTCTACATCCCTTCGATCACCGGCTACTGGGCGTTCGGCAGCCACGTCCAGTCCAACGTCCTCAAGAGCCTCATGCCGGACACCGGCCCGGCCCTCGCCCCGACGTGGCTGCTCGGCCtcgccgtcctcttcgtcctcctccagctcctcgccatcggcctcgtctactccCAGGTGGCGTACGAGATCATGGAGAAGAGCTCCGCGGACGCGACGCGGGGGAAGTTCTCGCGGCGGAACGTGGTGCCCCGGCTGCTCCTGCGGACGCTCTACCTCGCCTTCTGCGCGTTCATGGCGGCCATGCTGCCCTTCTTCGGCGACATCGTCGGCGTGGTCGGCGCCGTGGGGTTCATCCCGCTCGACTTCGTCCTCCCCGTCGTCATGTACAACATCGCGCTCGCGCCGCCCAGGCGGTCGCCGATGTTCCTCGCCAACACGGCCATCA</a:t>
            </a:r>
            <a:r>
              <a:rPr lang="en-US" altLang="zh-CN" sz="900">
                <a:highlight>
                  <a:srgbClr val="FFFF00"/>
                </a:highlight>
                <a:latin typeface="等线" panose="02010600030101010101" charset="-122"/>
                <a:ea typeface="等线" panose="02010600030101010101" charset="-122"/>
              </a:rPr>
              <a:t>TGGTCGTCTTCTCCGGCGTCGGG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GCCATCGGCGCATTCGCCTCCATACGGAAGCTCGTGCTCGACGCTGGACAGTTTAAGCTCTTCAGCAACAACGTCGTGGACTAA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260350" y="218440"/>
            <a:ext cx="6148070" cy="8703945"/>
          </a:xfrm>
          <a:prstGeom prst="rect">
            <a:avLst/>
          </a:prstGeom>
        </p:spPr>
        <p:txBody>
          <a:bodyPr>
            <a:no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2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:</a:t>
            </a:r>
            <a:endParaRPr lang="en-US" altLang="zh-CN" sz="900">
              <a:latin typeface="等线" panose="02010600030101010101" charset="-122"/>
              <a:ea typeface="等线" panose="02010600030101010101" charset="-122"/>
              <a:sym typeface="+mn-ea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&gt;Os02g0556400 class=Sequence_position=chr02:21039695..21042737 (-strand)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GATTCCCTCCTCTCCCCTCCTCTCCGCCCGCTCGCCGCCGCCGCCGCCCGCGTCGACTCGCCGGAGCTGAGCCCGGTAGGGCCACACGCCGAGCCGACAGGATGTGGTACCTCTGCGTCTTCTACCACAGGCTCCTCGACTACCGGCGGCCCGAGGTGCAGTCCCTCGCCGAGCTCTTCGGCGGGCCTGGCGCCGGGGACGCCGTCGAGTGGCGCATGCCGGAGAACCACCACGTCGACTCCCCCTTCCACCTCGTCCGCCTCCCGGGCGACGAGCGCCTCGCCGCGCAGATCGCCAACCGCAGTAAAAGCGCCTCGCCTGATCGATTGATTCACCACCATTCGCTGGCTAAGCTTCTTCTTGCGGGTTAATCTTGGGGGGCGCCGCGACGCCATGTGTGTGTTTGTAGGCTTGCTGGTGAAGGGGATCTACGAGCTGTGGGGGCAAGGCACCACCTACGAGGAGCTGGAGAGGGTGGTCATGGCGTACCCCGAGGAGAGGAAGCTGCCGTA</a:t>
            </a:r>
            <a:r>
              <a:rPr lang="en-US" altLang="zh-CN" sz="900">
                <a:highlight>
                  <a:srgbClr val="FFFF00"/>
                </a:highlight>
                <a:latin typeface="等线" panose="02010600030101010101" charset="-122"/>
                <a:ea typeface="等线" panose="02010600030101010101" charset="-122"/>
              </a:rPr>
              <a:t>CCTGACGCCGGAGAGCACCTTCA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AGATCGTCGTCGACAGCTTCGGCAAGGTCATCAGCTTCCAGGAGCAGAACGACATCATGAAGAGCCTCACCTACATCCCCTTCAAGGTAAATTCATTTTTGAGccataataagttcaattttagcctccccagtttgtcccaaaataagttcatttttgagtaaccactgcatcggagtttatgaaaatagaagataaatatgttaggagtagataaagtgaggaataattgcgttgggatttgataaagtaggtattatagtcttttttatgttgtattggtattggattggtgaaaaatgaacttattttgggacgaagggagtTCATGGAGTAGTTCGGATCACGAATTTGTGGATGTCAGATGCATTTATTTTCTCTTGTGTGTAATTGGTGCTGTTCCTCATTTCCAGGGCCGTGTTAATTTGAAGAAGCCCGATCATAAGTTCTTTGTCATGGAGACTGATGACTATGGCTGCAACAATGGCCTCCCGCCGGTTGCTCAGAGGACGGTATTCTTTGGCCGCGAGGTTGGAGCGGCGGATAGGCATCTCCTGCCGACATATCAGCTGAAGAGCAGGAAGTATATTGGCCCGACCGCAATGGATGCTGAAATGGCATTTCTTATGGCGAATCAAGGGCTGGCGCGCCCCGGGAAGCTCGTATATGACCCTTTTGTTGGGACTGGGAGTATTTTGGTTGCAGCCGCGCATTTTGGAGCCATGACAATGGTTTGTGCTTATTGCACGGATAACGAATAATTTTCATTCTGCTTGTGAGTATGTCTTACTGATAAAGGCCTTTCAGGGTGCAGATATTGATATAAGGGTTGTGCGGGACGGTCGTGGTCCAGATTGCAATATTTGGAGCAACTTTGAGCAGGTGATTGATTGAAGTTAGCTATTATTTTTTGCTTAGATTCTTCCATCCTGTTGTGATCTGCTTGATTCTGTGTGAGCTGCAATTCTCTTATGACAGTTAGTTCTTAAACGCTGTTCTTGCCTAGTTTTTGACTTGGTATCATATAGCTTATGCAGATTATGTGTACTAACTATAGTGACATTTCGGCATTTATCACTTGTTAGTAAAACACCCGAGGTTCGTGTGAAGTACTAATTATATTGTCTTCTTCAGTACAAATTGCCGGAACCATTATGTATACTAAGAGCGGATAACAACGTCCCACCTTGGCGTCCAGGATTGAAGGAGGTAATACTCTGTTGTGCGGTTTATACATTGTTGTATTTTTTTGAATTTTACAGTTTTGACAGTGTAAGCTTGTACTATATGCGCGACTAAAAACTGAAACAAATGTGAGGAACGCATAAAGTGATTCCTGTACATTCATGCAATATTTTAGTTGTGCTTGAAATCTTGGATTTGTTATTTACATTCTTGCATTGCTTTATTTGGTTGACATTGCTTGAGAAAATGGTTGATGCTGAAGTAATTGAATTCTCACGTAGCTTTTTAACTGATG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3:</a:t>
            </a:r>
            <a:endParaRPr lang="en-US" altLang="zh-CN" sz="900">
              <a:latin typeface="等线" panose="02010600030101010101" charset="-122"/>
              <a:ea typeface="等线" panose="02010600030101010101" charset="-122"/>
              <a:sym typeface="+mn-ea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&gt;Os01g0587400 class=Sequence_position=chr01:22879904..22895941 (-strand)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GGCTCGCCTGGAACGGCAGCCACCAGTACTGGAGAGGCGGCGGCGGCAACTGGACGACCGCGCCGGAGGAATCGGGACCTGAAGGTCAGTCGCCGTACACCTTCCTCTACGTCGACGCCGAGAACGAGAGCTACGTCGTCTTCGAAGTCAAGGACGAGGCCCTGTTGTCGCGGATCGTCGTGGGAGTGGCGGGGCAGATCATGCTGTGGGGGTGGGTGGAGTCCGCCGCCACCTGGGTGCTCTTCTGGTCAGAGCCCACGCTGTGCGACGTCTACTCGCTCTGCGGCTCCTTCAGCGTCTGCACCGACGGCTCTGTGCCGGAGTGCGGCTGCCTCCAGGGATTCGTGGAGCGGCAGCCGCGGCAGTGGCTGTACGGCGACCAAACCGCTGGCTGCGCCCGGATCACCGGCCTGCAGATGCCGTGCGGCGGCGGCGGCCAGGCGTCGGGCAAGACGACGAAGCGCGACGACACGTTCTTCACGATGCCCAAGGCGAACAGTCTGCCCACCGGCGGCGTGGCCGCGCCGTCCGCGACCGCGAGCGCTCACGACGACTGCGAGCTCGCGTGCCTCGGCAACTGCTCCTGCACCGCCTACTCCTACAACGGCAGCTGCACGCTCTGGTACGGCGACCTCATCAACCTCCGGGGCGCGAACGGCTCCGGCACCGACGGCTACAGAATTTCGATCCGCCTCGGCGTGGCGTCCGACTTGTCCGGCACCGGGAACACCAAGAAAATGACCATCGGACTCGTCGTCGCCGGAGTTGTCGCCGCCGCAGTGACCCTCGCCGTTCTGGTCGCGGTGCTCGTCATGAGAAGCAGAAGGGCGAAGGCGTTGCGGAGACTGGAGGACTCCTCCTCCTTCTTGACGGTGTTCACGTACCGTGACCTGCAGCTCGTGACCAACAACTTCTCCGACAAGATCGGCGGCGGCGCCTTCGGGTCGGTGTTCAAGGGCGCGCTGCCGGGGGACGCGACGCCGGTGGCGGTGAAGAAGCTCGAGGGCGTTGGTCAGGGCGAGAAGCAGTTCCGCGCGGAGGTGAGCACCATCGGCATGATCCAGCACGTCAACCTGATCAGGCTGCTCGGCTTCTGCACCGACCGAACACGGAGGCTGCTCGTGTACGAGCACATGCCCAACGGCTCGCTGGACAGGCACCTCTTCGGCTCCGGCTCCGGCCATGGCGGCGGCGTCCTGAGCTGGAAGACGAGGTACCAGATCGCCCTGGGCGTCgcgagagggctgcactacctgcacgacaagtgcagggaccgcatcatccactgcgacgtcaagccggagaacatcctcctcgacggcgcgttcgccgccaaggtcgccgacttggggctcgccaagctcatgggccgcgacgactccagccgcgtgctgacgacgacgcgcgggaccgtggggta</a:t>
            </a:r>
            <a:r>
              <a:rPr lang="en-US" altLang="zh-CN" sz="900">
                <a:highlight>
                  <a:srgbClr val="FFFF00"/>
                </a:highlight>
                <a:latin typeface="等线" panose="02010600030101010101" charset="-122"/>
                <a:ea typeface="等线" panose="02010600030101010101" charset="-122"/>
              </a:rPr>
              <a:t>cctggcgccggagtggatcgccg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gcacggcggtcacggcgaaggcggacgtgtacagctacgggatgatgctgttcgagatcGTATCCGGGAGGAGGAACGTGGAGCAGCGGCGGCGGCAGGCGGAGGCGGCCGACGACGACGAGTACGACAGCGGCGCCGGCGGCACGGTGGAGGCGGACTTCTTCCCGTTGACGGCGGTGAGGATGCTGTTCGACGGCGACGGCGACCTCAGGGACGCGGTGGACGGCAATCTGGGCGGGGAGGTCGACATGGGAGAGGTGGAGAGGGCGTGCAAGGTGGCGTGCTGGTGCGTGCAGGACGCGGAGAGCGCGAGGCCGACCATGGGGATGGTGGTGAAGGCCCTGGAGGGGCTCGTCGACGTCAACTTTCCCCCGATGCCGAGGTTGTTCATGGTAGGGCTGTCAACGGGCTCTTCTCACACATAAGCTACTTGGAGTTGGAGTAGCTTATGACAAATTTAAaaataaaatatattaatatacgcaaaatctatttcgagaggcatcttgatttagacttaacgagcgacGCAGACAATTACGTGAGAAGTACCAGTAGCGTTACAGACATGCATGCAAGTAGTTTTTCTATTAGGTTGTGCATTTTTTTcttcttatgaaattttctcttaaactattcatccgatctacgatccgattacaccattgtgttcg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31470" y="8978900"/>
            <a:ext cx="6076950" cy="41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lnSpc>
                <a:spcPct val="1300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omic locations and sequence information of potential off-target sites </a:t>
            </a:r>
            <a:r>
              <a:rPr lang="en-US" altLang="zh-CN" sz="8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 to 6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ith the potential target sites highlighted in yellow. (Continued)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260350" y="218440"/>
            <a:ext cx="6148070" cy="8703945"/>
          </a:xfrm>
          <a:prstGeom prst="rect">
            <a:avLst/>
          </a:prstGeom>
        </p:spPr>
        <p:txBody>
          <a:bodyPr>
            <a:no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4:</a:t>
            </a:r>
            <a:endParaRPr lang="en-US" altLang="zh-CN" sz="900">
              <a:latin typeface="等线" panose="02010600030101010101" charset="-122"/>
              <a:ea typeface="等线" panose="02010600030101010101" charset="-122"/>
              <a:sym typeface="+mn-ea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&gt;Os03g0838100 class=Sequence_position=chr03:35219477..35222805 (-strand)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ATGTAAACTAATTGAGCACTTGAGGTGTTGAAGTGGCGTTAATTAGTCCAATAAGCAGACGATTTGACCCTAATAGAGTCATTACAAGGAGCAGCCCGGTCGGTCAGTGTGTGTCACTGTCTCTCACCCTCCCAACGCTTAGACATTTCAACGTTCTCCTCCACAGCAACAGCAGCAGCAGCAGCATCTCCTCTTCTTCACCGCATCTGCCAGCCTAGCGAGCCTAATCAGGTCTTCGTCTTCTTCTTCCTCATCCCCGTGCCAATACCGATTTcgcgagctccgatggattccgcgagagaggagacgtcgccatgagaggggaagccgagctgtgcgtgtagctcgctgcaatcgctgcgccggtcaagaaaccagccggaatcggcggctgattccggtggaggaagatgcggcggaaggcggccggAGATGCTGCTCTGGTAGGCGGCTGCTTCTTGCTGCTCCTCCACCCTCTCCTCTCCCATGGCGCGGACATGCCGTTGGGCTCCTCCCTCTCGCCGGCGAACCAGGCGTTGTGGTCGTCTCCCAACAACACCTTCTCCCTCTCCTTCACGGCGTCCCCGACCTCGCCGTCCCTCTTCGTCGCCGCCATCACCTACGCCGGCGGGGTGCCCGTGTGGACGGCCGGCAACGGCGCGACCGTTGACTCCGGTGGCGCGCTCCGCCTCTCGTCCAGCGGCGACCTCCAGCTCGTCAACGGCTCCGGCGCCGTGGTCTGGTCATCGAACACCGGCGGGCAGGGGGTCACCACCGCCGCGCTGCAGGAGAGCGGCAACCTCCTGCTCAGGAACTCGTCGGCGACGTTGTGGCAATCGTTCGAACACCCCACGGACACGGTGGTGATGGGGCAGAACTTCACCTCCGGCATGAACCTCACCTCGGCGAGCTACCAATTCTCCCTCGACCGGAACACCGGCAACCTCACCCTCAAGTGGACCGGCGGCGGCACGGTCACCTACTTCAACAAGGGGTACAACACCACCTTCACGGCGAACAAGACGCTGAGCTCGCCGACGCTGGCGATGCAAACCAACGGTATCGTCTCCCTCACCGACGGCTCGCTCACCTCTCCCGTCGTCGTCGCGTACAGCAGCAACTACGGCGAGAGCGGCGACATGCTGAGGTTCGTGCGCCTAGACACGGACGGCAACTTCCGCGCCTACAGCGCGGCGCGCGGCAGCAACGCGCCGACGGAGCAGTGGTCGGCGGTGGCGGACCAGTGCCAGGTGTTCGGCTACTGCGGCAACATGGGCGTGTGCGGCTACAACGGCACGTCGCCGGTGTGCCGGTGCCCGTCGGAGAACTTCCAGCTGAGCAACCCGGCCGACCCGCGCGGCGGCTGCCGGCGCAAGATCGAGCTCCAGAACTGCCCGGGCAACTCCACCATGCTCCAGCTCGACAACACGCAGTTCCTGACCTACCCGCCGGAGATCACGACGGAGCAGTTCTTCGTCGGCATCACCGCCTGCCGCCTCAACTGCCTCTCCGGCAGCTCGTGCGTCGCCTCCACGGCGCTCTCCGACGGCTCGGGCCTCTGCTTCCTCAAGGTGTCCAACTTCGTCAGCGGGTACCAGTCCGCGGCGCTGCCCAGCACGTCGTTCGTCAAGGTCTGCTTCCCGGGGATCCCCAACCCGCCCCTCGGCGGCGGCGGGTCGCCGTCGGGCAGGGCGTCGGGCGTCCGCGGGTGGGTGGTCGCGGTGGTGGTGCTCGGCGCGGTGTCCGGGCTGGTGCTGTGCGAGTGGGCGCTGTGGTGGGTGTTCTGCCGGCACAGCCCCAAGTACGGCGCGGCGTCGGCGCAGTACGCGCTGCTGGAGTACGCGTCCGGCGCGCCGGTGCAGTTCTCGTACCGGGAGCTGCAGCGATCGACCAAGGGGTTCAAGGAGAAGCTGGGCGCCGGCGGGTTCGGCGCCGTGTACCGCGGCGTGCTGGCGAACCGGACGGTGGTGGCGGTGAAGCAGCTGGAGGGGATCGAGCAGGGGGAGAAGCAGTTCAGGATGGAGGTGGCCACCATCAGCAGCACGCACCACCTCAACCTCGTCCGCCTCATCGGCTTCTGCTCCGAGGGGCGCCACCGCCTGCTCGTCTACGAGTTCATGAAGAACGGCTCCCTCGACGCCTTCCTCTTCGCCGACGCGCCGGGCGGCAGGATGCCGTGGCCGACGCGGTTCGCCGTCGCCGTCGGCACCGCCCGCGGCATCACctacctccacgaggagtgccgcgactgcatcgtccactgcgacatcaagcccgagaacatcctcctcgacgagcaccacaacgccaaggtctccgacttcggcctcgccaagctcgtcaaccccaaggatcaccgccaccggacgctcaccagcgtgcgcgggacgaggggctacctcgcgccggagtggctcgccaacctccccatcacggccaagtccgacgtctacagctacggcatggtgctgctcgagctcgtcagcggccACCGCAACTTCGACGTGTCGGAGGAGACCGGCCGGAAGAAGTACTCCGTGTGGGCGTACGAGGAGTACGAGAAGGGGAACATCGCCGCCATTgtcgacaagaagctccccggggaggacatcgacatggtccaggtggagcgcgcgctgcaggtgagcttctggtgcatccaggagcagccggcgcagcggccgtcgatggggaaggtggtgcagatgctggaagggatcatggatctcgagagGCCGCCGCCGCCCAAGTCGTCGGACAGCTTCTTGAG</a:t>
            </a:r>
            <a:r>
              <a:rPr lang="en-US" altLang="zh-CN" sz="900">
                <a:highlight>
                  <a:srgbClr val="FFFF00"/>
                </a:highlight>
                <a:latin typeface="等线" panose="02010600030101010101" charset="-122"/>
                <a:ea typeface="等线" panose="02010600030101010101" charset="-122"/>
              </a:rPr>
              <a:t>CCTGACGTCGGCGACCACCGCC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ACCGGTGTCAGCGGCAGCGGCAGCACCAGCATGGTCTCCACGTTTACTTCCTCGGCGGCGCCGCCGGCGCCCACGCCGTCGCCGAACGTCGACGAGGTCCAGCAGGAGATGGCCGTGGGACGCTCGGCGTCGGCCAGGATCCGCGACCGGGCGTCTCGTTCGCTGCTGGGGCAGGAGCCATACATGACAATGTAAAACTTCATCTTCTCATGAGGTGAATAGCAAAATGATTTTGCTTTTTTTTTTTGCTCCAGTAAATGGGAAAATTGCTCTGGTTAGTGAGCAATTAGGGAGTTGATCTG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5:</a:t>
            </a:r>
            <a:endParaRPr lang="en-US" altLang="zh-CN" sz="900">
              <a:latin typeface="等线" panose="02010600030101010101" charset="-122"/>
              <a:ea typeface="等线" panose="02010600030101010101" charset="-122"/>
              <a:sym typeface="+mn-ea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&gt;Os09g0426800 class=Sequence_position=chr09:15493031..15497466 (+strand)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ACCAGCCGCGTTGGGTGCAAAACCACAACCGCCAACATCTTCTAACTCCCCTCACGGCTCTCCCTCTCCCCGCACGCACAACACCGGTGAACCCCTACGTACTACTGAGCTGAGCTGAGAGGACGAAGAAGAAGATCAAGCTCGAGGGGCTTGCGATCATGGGTGCCGCATTCTTGTCGTCGTGGCCATGGGATAACCTCGGCGCGTACAAGGTATTTGTGCAGTTTGCTCCGTTCGTTGGGTTGATCGGTTTCCGGCATTGTTGATGGTGGATTGATTGTGTGTGCGCAGTATGTGTTGTACGCGCCGCTGGTGGGGAAGGCGGTGGCGGGGCGGGCGTGGGAGCGGGCGAGCCCCGACCACTGGCTGCTGCTGC</a:t>
            </a:r>
            <a:r>
              <a:rPr lang="en-US" altLang="zh-CN" sz="900">
                <a:highlight>
                  <a:srgbClr val="FFFF00"/>
                </a:highlight>
                <a:latin typeface="等线" panose="02010600030101010101" charset="-122"/>
                <a:ea typeface="等线" panose="02010600030101010101" charset="-122"/>
              </a:rPr>
              <a:t>TGCTCGTCCTCTTCGGCGTCAGG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GCCTTGACCTACCAGCTCTGGAGCTCGTTCAGCAACATGCTCTTCGCCACCCGCCGCCGCCGCATCGTCCGCGACGGCGTCGACTTCGGCCAGATCGACAGGGAGTGGGACTGGTACGCACGAACGCGCGCTCGCCGCCGGTGCAACTTAGCTCGATCGATCAGCCAGCTGAATAATCTGTGTGTTGGGGTTTGCTTCTGCAGGGACAACTTCTTGATACTGCAGGTGCACATGGCGGCGGCGGCGTTCTACGCGTTCCCGTCGCTGCGGCACCTCCCGCTGTGGGACGCCAGGGGCCTCGCCGTCGCCGCGCTCCTCCACGTCGCCGCCACCGAGCCCCTGTTCTACGCCGCGCACAGGGCGTTCCACCGCGGCCACCTCTTCTCCTGCTACCACTTGCAACACCACTCCGCCAAGGTGCCCCAGCCATTCACAGGTAAGCATGCATCTCGCGCGCGCCGCCCACAGATCGAGTACCGATCCGCCGCCGGCGATCGATCGAAGCTAATTAACTCCGTCAATTGATCGCCGGTGCATGCGCAGCGGGGTTCGCGACGCCGCTGGAGCAGCTGGTGCTGGGGGCGCTCATGGCGGTGCCGCTGGCGGCGGCGTGCGCGGCGGGGCACGG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31470" y="9130665"/>
            <a:ext cx="6076950" cy="41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lnSpc>
                <a:spcPct val="1300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omic locations and sequence information of potential off-target sites </a:t>
            </a:r>
            <a:r>
              <a:rPr lang="en-US" altLang="zh-CN" sz="8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 to 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, with the potential target sites highlighted in yellow. (Continued)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260350" y="218440"/>
            <a:ext cx="6148070" cy="8703945"/>
          </a:xfrm>
          <a:prstGeom prst="rect">
            <a:avLst/>
          </a:prstGeom>
        </p:spPr>
        <p:txBody>
          <a:bodyPr>
            <a:noAutofit/>
          </a:bodyPr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  <a:sym typeface="+mn-ea"/>
              </a:rPr>
              <a:t>6:</a:t>
            </a:r>
            <a:endParaRPr lang="en-US" altLang="zh-CN" sz="900">
              <a:latin typeface="等线" panose="02010600030101010101" charset="-122"/>
              <a:ea typeface="等线" panose="02010600030101010101" charset="-122"/>
              <a:sym typeface="+mn-ea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&gt;Os01g0656200 class=Sequence_position=chr01:26652966..26658299 (+strand)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  <a:p>
            <a:pPr defTabSz="266700">
              <a:lnSpc>
                <a:spcPct val="115000"/>
              </a:lnSpc>
              <a:spcAft>
                <a:spcPts val="800"/>
              </a:spcAft>
            </a:pP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CTCTCTTTTGCTCTCTCTGGTGAGGGAAATGAGCAGTGACACAAGCAGGCGGGATCATGCCGCCATGGCCGTGC</a:t>
            </a:r>
            <a:r>
              <a:rPr lang="en-US" altLang="zh-CN" sz="900">
                <a:highlight>
                  <a:srgbClr val="FFFF00"/>
                </a:highlight>
                <a:latin typeface="等线" panose="02010600030101010101" charset="-122"/>
                <a:ea typeface="等线" panose="02010600030101010101" charset="-122"/>
              </a:rPr>
              <a:t>GGGAGGTCCTCGCCGGCGACAGG</a:t>
            </a:r>
            <a:r>
              <a:rPr lang="en-US" altLang="zh-CN" sz="900">
                <a:latin typeface="等线" panose="02010600030101010101" charset="-122"/>
                <a:ea typeface="等线" panose="02010600030101010101" charset="-122"/>
              </a:rPr>
              <a:t>AAGGTGGGCACCGTGTCCAGGTCGGCGAGGAGGAGGAGGCTTGAGCTCCGGAGGCTCGGGCGGACGGCGTCGGCGGTGGCGGAGGATGACGCCGCGAAGAGGGTGCGGCCGGCGTCGGACAGCTCCTCCGACTCGTCGGAGTCGGCTAAGGTAGCGCCCGAGCCCACCGCGGAGGTGGCGAGATGGCCGGCGTGCGTGTCGCACGGGGCGGTGTCGGTGATCGGGCGCCGGAGGGAGATGGAAGACGCCATCTTCGTCGCGGCGCCGTTCTTGGCCGCCTCGAAGGAGGCGGCGGTGGAGGGGAGCGGCGTCGCGGAAGAGGAAGGCAAGGAGGAGGATGAGGGGTTCTTCGCGGTGTACGACGGGCACGGCGGGTCCCGCGTGGCGGAGGCGTGCCGGGAGCGGATGCACGTGGTGCTCGCGGAGGAGGTGCGGGTGCGGAGGCTGCTGCAGGGCGGGGGCGGCGGCGCCGACGTCGAGGACGAGGACCGCGCCCGTTGGAAGGAGGCCATGGCGGCCTGCTTCACCCGCGTGGACGGCGAGGTCGGCGGCGCCGAGGAGGCCGACACGGGCGAGCAGACGGTGGGCTCCACCGCCGTCGTCGCCGTCGTGGGTCCCCGCCGCATCGTCGTCGCCAACTGCGGCGACTCCCGCGCCGTCCTCTCCCGCGGCGGCGTGGCCGTGCCGCTCTCCTCCGACCACAAGGTACACACTCCACGCCACGCCCCCACCCGCTCACCTCACCGCCTAACAAAACACATCGCCAAGAAAGCATGCATCAACGGCATGATTACCCCCCCCCCCCCCCCCCCCTCCAAACCACGCGCTCCAGATCCACACTAATCTAGATTTTGCGGGGTGCAACCTGCAACAGCGAACCCTGCTGCGAATCAGGGACGCGTGGACGTCGTCGTCAAAGCACCACGGTTTCGGGCTTTCCGCGAGATTTTTTTTTTCTCTCGCTCGGGCGGGCCCCGGGGGGGGGGGGGGGGTGGTGGTTACGTACAGGTGTCGCCCTTGCCGCTCGCTCCCCCCGCGTCGCCTACAACAACAACTACCACCTCTGCTTTTCGTGCGTGCGGGCCGTGTCGAAGCGTCCCCGCTGGCTCGCCTACTCGTCGCTTTTGGTAGCGTACTGTGGCGCCGCTGCCGATACGTACGTGCAAGGCTACATCACCGCGCCCTACTAGCTACCACCACGTACGTTTGCGCCAAAACGGAAGGCGATTTGCGGTGAATTGGAGAGGAGGGTGCGGTGGTGTGGTGTGGGCGTGTGGGACTAGGCCGCCTTGTCACGTTGTGTGCGAATGGGGGTGAATTTGCGGAGACTCTCCTACCTCCCTGGCCGGAGTCGTTGGGGGGGGGGGGGGGGGGGTAAATGACCAAATCCGGCCTGGAGTACTAATCGTCGCGGAGAGGTGTCGACACGCGCGCGCGCGCGCGCGCACGTACGTACGTGCATTGTGTACGCCATTGGGGCTAGCTGTCGAGTGGTGTAGGAGTGATAGTGCTCTGCTCCTGGTTACCAAGTAGTAGTACCAAGAGTGTGCCGGCAGAGTTTGGATGGCTCAGAGTCAGTTTGGAATAGAACGGATCGGTTTCTGATGCTCTCGCTATCCTTGTGGGCAAAGGCGAGCATCAGCTTTTCCTTGTCCTACCAGGGCTAATCTGCTGATAGCGCGCGGCATGTGTTTCAAGCTTCTTCCTGGTTGTCATTACAGTGATGCTTGAGATGATGGGCAGACAGCAGCATAGGGTCAGGGCATTAATTAGCTAAACTGGGATTATGGCCTCTGGGAAGAGGCAGGCTAATACACATACAACATCCAAGATGATTTATCCTAGCTGCTTAGAGTTGAGAATTGCGGAATCACTGCCTTTTAACTGACAAGTCAGGTCAATGTCTTCGCTAGGCCGTTAGGTGCTAAATTCCCTGGAACTGTGGTGAGGATCTGAGGATGAGTTCTTCCCTTTGTTTATATTTTGTTTTGAAATGGTATCTAGAATCGTGTTCAACTTCATGGAAACTAAGAccatgtttagttcctccaaaatggcaaatgttttgctgttttggagcactttttgtcaaaatggatctaaatactagtagcataagttgacaatctgacctttgtcatttaggagtctagagtagcaaattttgccaaaaagtgcgtttggagccgtgctctctctctttactagtaaaatggcaaaactttaccatgcatctaaacactaactagcaaaacttcaatgccaaatcttttgccaccaaaacttttgccaagaaaatttgccacaacaaattgatctaaacaggcccTAAGACTTTTGTGTACAGCTATGTGGGGGTTTGGAAAGATAGGCTCATAGGCTGCAACTCTGCACGTGCCGAAAATAAACTGGCAATTGCCAAGAGAGATACTTCAAACATGAGTGTCAAACTGCTTTCTCTGTTTTGCCTGTCCCTTTCCTAAGTGTGATGAAGTTCCCTTTCGCGGAACGAAACCGCAAGGGCTTCTATTGCCGTAATCAACTTGTGTTATTTAGTTTTGTAAGTTTGGTAGTGGTATGCATTAGGAGTGAGCAAAGTTTCTCTTTACAGTGTTTGGCTAGGTCTGGATTTGTACCGCCATATGCCCTTGTGCTCAAATAGTGCAACCGGGCATCTATTGACTCAAGCTACCTTTTGCTTTGTTATTGATGGCTAGCTTAACTTCTTTAGTTTATTGATGCCAAATTAAAGGTCTACTTTTATATAGTCAAAGTTCGATTTAACTCCAGCTCTCTAGGATAATATTGCTTTACCGGTTTCTGTAAAGAAAACTCCCCCATGCCCTTAACAATTTACACGGTGTTTGCATCTTATTCAGCCCTGTTGAGCTTGAATGTACCGTATTGGATGTTTTTCTTAATTAATATATCTTTTTCTCAACTACAATAAATGTTTAGATGTCAGAAAAAAAGCTATCTTAAGCTTTAATCTGTACACAAAGGTACTTGATTTTGGTATTGGAGGCATCTTTGACTATCCATATATTTAATTGCTATATTCTTCAGTTTTTACAATGCTAATGCCATGCTGTGGACACTGGACAGTGCTCGTAGGTATATGATACATGCCTAGAAGGTAGATGTAGCTATGGGGAGCAAAACGTTTGGCTTTTTAGGGTGTGATGAAGTTGAGATTGGTGTCTACAGTAAGTGTATGCATGAACACTACTAGAGGCAGGTGAAGAAATAATGTGTTGTAGATGCTGGTGTGTCAAGTTATATCAAGTGTGGTAGTTGTTTATTGAAGTATCGTCAGGCTGCTGCGTTAAGCATTGTCATTCATCAGCTAGGCGTTTTAAGTGTCATTGTGGGGACCAACCTCGATTATATAGCATGCAAGCCTTGAACTGTAATGATGTTCAGAAAAGATATTCAATAGTCCTATATGTGTGCTTGAATAAATTTGTTAGCGAGATGAGAAAGTTCAAAATATTGGCCACAGCTCCTAAATACGTGGAAGTTCGTGCTACACAGCACAACCAAGATATTGTAGTCATATTGTCACTTCATTTAGATATTTCTATTTGGGGTGATAGGAAATTGGCAGAGTGGTTAAGGAAGGTTGTTGACAAACAATTTTCCTGTTCGTTACACTGTCAATACCGAAAAAGCTAAAAGTTTCCAGTCGCACTTGATATGGCTTGACATATCCGCAACTAGAACATATAATTTTCTTGACATTCGCTGACAGTTCATGCATTATACTTCCTTTAGATACCAACTCTGCTTCATCCAATATGTCCTTTCTGTTAGAGCAGCTTTATACAAAAGCACTGATGCTTCATCATATCCATCATTTTAAACCACAAGTTGTGCATATTGTCTCGTCTGCCACCTGCCGAGTACAAAAACATAAACTTCATAATATCCTGAAATGTGGAAGTTCTGAACTATGTATTGCTCCCTTTGCCTAAACAAAGCCTTTTATATTTGCATTTTTCTCCTGTGACCAGTGTATTTTTGGGGGTTAGCTTCCTCCTTTAGTACTTCTCTTGATTTGTGGTTTCATTTTGTCAGGGGCGTAATGCTTGTTGCAGCAAATGTTAATGAAACTTTTGTTGACTGTACACAGCCAGACAGACCTGACGAGATGGAGAGAGTAGAAGCAGCAGGTGGCAGGGTTATCAATTGGAATGGATACCGTATCCTCGGTGTCCTTGCTACTTCTAGGTCAATTGGTACGTTTTTGTCTTCTGTTGCCCTCAACGTTTTCTAAACAAAGATAATCAACATGCTTGATACTTTTAGCTGAGACTAGCAATTGTAGTATCTGTGAAAGAGAGAATATACAGCTGAATGTAGATCATTTTTTCATATGCAA</a:t>
            </a:r>
            <a:endParaRPr lang="en-US" altLang="zh-CN" sz="900">
              <a:latin typeface="等线" panose="02010600030101010101" charset="-122"/>
              <a:ea typeface="等线" panose="02010600030101010101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31470" y="9102725"/>
            <a:ext cx="6113780" cy="41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lnSpc>
                <a:spcPct val="130000"/>
              </a:lnSpc>
            </a:pPr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S2.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enomic locations and sequence information of potential off-target sites </a:t>
            </a:r>
            <a:r>
              <a:rPr lang="en-US" altLang="zh-CN" sz="800">
                <a:latin typeface="等线" panose="02010600030101010101" charset="-122"/>
                <a:ea typeface="等线" panose="02010600030101010101" charset="-122"/>
                <a:sym typeface="+mn-ea"/>
              </a:rPr>
              <a:t>OFF-target sites 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to 6, with the potential target sites highlighted in yellow. (Continued)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680</Words>
  <Application>WPS 演示</Application>
  <PresentationFormat>A4 纸张(210x297 毫米)</PresentationFormat>
  <Paragraphs>30</Paragraphs>
  <Slides>4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7" baseType="lpstr">
      <vt:lpstr>Arial</vt:lpstr>
      <vt:lpstr>宋体</vt:lpstr>
      <vt:lpstr>Wingdings</vt:lpstr>
      <vt:lpstr>Courier New</vt:lpstr>
      <vt:lpstr>Times New Roman</vt:lpstr>
      <vt:lpstr>Calibri</vt:lpstr>
      <vt:lpstr>Times New Roman</vt:lpstr>
      <vt:lpstr>等线</vt:lpstr>
      <vt:lpstr>微软雅黑</vt:lpstr>
      <vt:lpstr>Arial Unicode MS</vt:lpstr>
      <vt:lpstr>等线 Light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sb</dc:creator>
  <cp:lastModifiedBy>朱义旺</cp:lastModifiedBy>
  <cp:revision>375</cp:revision>
  <dcterms:created xsi:type="dcterms:W3CDTF">2018-09-24T01:01:00Z</dcterms:created>
  <dcterms:modified xsi:type="dcterms:W3CDTF">2025-12-18T03:48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034</vt:lpwstr>
  </property>
  <property fmtid="{D5CDD505-2E9C-101B-9397-08002B2CF9AE}" pid="3" name="ICV">
    <vt:lpwstr>61B4EB843F6F44DC99892200BB848769_12</vt:lpwstr>
  </property>
</Properties>
</file>